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2" r:id="rId2"/>
  </p:sldIdLst>
  <p:sldSz cx="11064875" cy="14630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08" userDrawn="1">
          <p15:clr>
            <a:srgbClr val="A4A3A4"/>
          </p15:clr>
        </p15:guide>
        <p15:guide id="2" pos="348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>
        <p:scale>
          <a:sx n="50" d="100"/>
          <a:sy n="50" d="100"/>
        </p:scale>
        <p:origin x="1368" y="-1900"/>
      </p:cViewPr>
      <p:guideLst>
        <p:guide orient="horz" pos="4608"/>
        <p:guide pos="348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29866" y="2394374"/>
            <a:ext cx="9405144" cy="5093547"/>
          </a:xfrm>
        </p:spPr>
        <p:txBody>
          <a:bodyPr anchor="b"/>
          <a:lstStyle>
            <a:lvl1pPr algn="ctr">
              <a:defRPr sz="726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83110" y="7684348"/>
            <a:ext cx="8298656" cy="3532292"/>
          </a:xfrm>
        </p:spPr>
        <p:txBody>
          <a:bodyPr/>
          <a:lstStyle>
            <a:lvl1pPr marL="0" indent="0" algn="ctr">
              <a:buNone/>
              <a:defRPr sz="2904"/>
            </a:lvl1pPr>
            <a:lvl2pPr marL="553258" indent="0" algn="ctr">
              <a:buNone/>
              <a:defRPr sz="2420"/>
            </a:lvl2pPr>
            <a:lvl3pPr marL="1106515" indent="0" algn="ctr">
              <a:buNone/>
              <a:defRPr sz="2178"/>
            </a:lvl3pPr>
            <a:lvl4pPr marL="1659773" indent="0" algn="ctr">
              <a:buNone/>
              <a:defRPr sz="1936"/>
            </a:lvl4pPr>
            <a:lvl5pPr marL="2213031" indent="0" algn="ctr">
              <a:buNone/>
              <a:defRPr sz="1936"/>
            </a:lvl5pPr>
            <a:lvl6pPr marL="2766289" indent="0" algn="ctr">
              <a:buNone/>
              <a:defRPr sz="1936"/>
            </a:lvl6pPr>
            <a:lvl7pPr marL="3319546" indent="0" algn="ctr">
              <a:buNone/>
              <a:defRPr sz="1936"/>
            </a:lvl7pPr>
            <a:lvl8pPr marL="3872804" indent="0" algn="ctr">
              <a:buNone/>
              <a:defRPr sz="1936"/>
            </a:lvl8pPr>
            <a:lvl9pPr marL="4426062" indent="0" algn="ctr">
              <a:buNone/>
              <a:defRPr sz="1936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C7F62-993A-4232-8570-CB5A3DEC7942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F608E-C378-4419-9361-F73511E64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81542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C7F62-993A-4232-8570-CB5A3DEC7942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F608E-C378-4419-9361-F73511E64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7685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918302" y="778933"/>
            <a:ext cx="2385864" cy="1239858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60711" y="778933"/>
            <a:ext cx="7019280" cy="1239858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C7F62-993A-4232-8570-CB5A3DEC7942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F608E-C378-4419-9361-F73511E64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1366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C7F62-993A-4232-8570-CB5A3DEC7942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F608E-C378-4419-9361-F73511E64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89774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4948" y="3647444"/>
            <a:ext cx="9543455" cy="6085839"/>
          </a:xfrm>
        </p:spPr>
        <p:txBody>
          <a:bodyPr anchor="b"/>
          <a:lstStyle>
            <a:lvl1pPr>
              <a:defRPr sz="726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4948" y="9790858"/>
            <a:ext cx="9543455" cy="3200399"/>
          </a:xfrm>
        </p:spPr>
        <p:txBody>
          <a:bodyPr/>
          <a:lstStyle>
            <a:lvl1pPr marL="0" indent="0">
              <a:buNone/>
              <a:defRPr sz="2904">
                <a:solidFill>
                  <a:schemeClr val="tx1"/>
                </a:solidFill>
              </a:defRPr>
            </a:lvl1pPr>
            <a:lvl2pPr marL="553258" indent="0">
              <a:buNone/>
              <a:defRPr sz="2420">
                <a:solidFill>
                  <a:schemeClr val="tx1">
                    <a:tint val="75000"/>
                  </a:schemeClr>
                </a:solidFill>
              </a:defRPr>
            </a:lvl2pPr>
            <a:lvl3pPr marL="1106515" indent="0">
              <a:buNone/>
              <a:defRPr sz="2178">
                <a:solidFill>
                  <a:schemeClr val="tx1">
                    <a:tint val="75000"/>
                  </a:schemeClr>
                </a:solidFill>
              </a:defRPr>
            </a:lvl3pPr>
            <a:lvl4pPr marL="1659773" indent="0">
              <a:buNone/>
              <a:defRPr sz="1936">
                <a:solidFill>
                  <a:schemeClr val="tx1">
                    <a:tint val="75000"/>
                  </a:schemeClr>
                </a:solidFill>
              </a:defRPr>
            </a:lvl4pPr>
            <a:lvl5pPr marL="2213031" indent="0">
              <a:buNone/>
              <a:defRPr sz="1936">
                <a:solidFill>
                  <a:schemeClr val="tx1">
                    <a:tint val="75000"/>
                  </a:schemeClr>
                </a:solidFill>
              </a:defRPr>
            </a:lvl5pPr>
            <a:lvl6pPr marL="2766289" indent="0">
              <a:buNone/>
              <a:defRPr sz="1936">
                <a:solidFill>
                  <a:schemeClr val="tx1">
                    <a:tint val="75000"/>
                  </a:schemeClr>
                </a:solidFill>
              </a:defRPr>
            </a:lvl6pPr>
            <a:lvl7pPr marL="3319546" indent="0">
              <a:buNone/>
              <a:defRPr sz="1936">
                <a:solidFill>
                  <a:schemeClr val="tx1">
                    <a:tint val="75000"/>
                  </a:schemeClr>
                </a:solidFill>
              </a:defRPr>
            </a:lvl7pPr>
            <a:lvl8pPr marL="3872804" indent="0">
              <a:buNone/>
              <a:defRPr sz="1936">
                <a:solidFill>
                  <a:schemeClr val="tx1">
                    <a:tint val="75000"/>
                  </a:schemeClr>
                </a:solidFill>
              </a:defRPr>
            </a:lvl8pPr>
            <a:lvl9pPr marL="4426062" indent="0">
              <a:buNone/>
              <a:defRPr sz="19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C7F62-993A-4232-8570-CB5A3DEC7942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F608E-C378-4419-9361-F73511E64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68326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60710" y="3894667"/>
            <a:ext cx="4702572" cy="928285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601593" y="3894667"/>
            <a:ext cx="4702572" cy="928285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C7F62-993A-4232-8570-CB5A3DEC7942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F608E-C378-4419-9361-F73511E64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2378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2151" y="778936"/>
            <a:ext cx="9543455" cy="282786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2153" y="3586481"/>
            <a:ext cx="4680960" cy="1757679"/>
          </a:xfrm>
        </p:spPr>
        <p:txBody>
          <a:bodyPr anchor="b"/>
          <a:lstStyle>
            <a:lvl1pPr marL="0" indent="0">
              <a:buNone/>
              <a:defRPr sz="2904" b="1"/>
            </a:lvl1pPr>
            <a:lvl2pPr marL="553258" indent="0">
              <a:buNone/>
              <a:defRPr sz="2420" b="1"/>
            </a:lvl2pPr>
            <a:lvl3pPr marL="1106515" indent="0">
              <a:buNone/>
              <a:defRPr sz="2178" b="1"/>
            </a:lvl3pPr>
            <a:lvl4pPr marL="1659773" indent="0">
              <a:buNone/>
              <a:defRPr sz="1936" b="1"/>
            </a:lvl4pPr>
            <a:lvl5pPr marL="2213031" indent="0">
              <a:buNone/>
              <a:defRPr sz="1936" b="1"/>
            </a:lvl5pPr>
            <a:lvl6pPr marL="2766289" indent="0">
              <a:buNone/>
              <a:defRPr sz="1936" b="1"/>
            </a:lvl6pPr>
            <a:lvl7pPr marL="3319546" indent="0">
              <a:buNone/>
              <a:defRPr sz="1936" b="1"/>
            </a:lvl7pPr>
            <a:lvl8pPr marL="3872804" indent="0">
              <a:buNone/>
              <a:defRPr sz="1936" b="1"/>
            </a:lvl8pPr>
            <a:lvl9pPr marL="4426062" indent="0">
              <a:buNone/>
              <a:defRPr sz="193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2153" y="5344160"/>
            <a:ext cx="4680960" cy="786045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601594" y="3586481"/>
            <a:ext cx="4704013" cy="1757679"/>
          </a:xfrm>
        </p:spPr>
        <p:txBody>
          <a:bodyPr anchor="b"/>
          <a:lstStyle>
            <a:lvl1pPr marL="0" indent="0">
              <a:buNone/>
              <a:defRPr sz="2904" b="1"/>
            </a:lvl1pPr>
            <a:lvl2pPr marL="553258" indent="0">
              <a:buNone/>
              <a:defRPr sz="2420" b="1"/>
            </a:lvl2pPr>
            <a:lvl3pPr marL="1106515" indent="0">
              <a:buNone/>
              <a:defRPr sz="2178" b="1"/>
            </a:lvl3pPr>
            <a:lvl4pPr marL="1659773" indent="0">
              <a:buNone/>
              <a:defRPr sz="1936" b="1"/>
            </a:lvl4pPr>
            <a:lvl5pPr marL="2213031" indent="0">
              <a:buNone/>
              <a:defRPr sz="1936" b="1"/>
            </a:lvl5pPr>
            <a:lvl6pPr marL="2766289" indent="0">
              <a:buNone/>
              <a:defRPr sz="1936" b="1"/>
            </a:lvl6pPr>
            <a:lvl7pPr marL="3319546" indent="0">
              <a:buNone/>
              <a:defRPr sz="1936" b="1"/>
            </a:lvl7pPr>
            <a:lvl8pPr marL="3872804" indent="0">
              <a:buNone/>
              <a:defRPr sz="1936" b="1"/>
            </a:lvl8pPr>
            <a:lvl9pPr marL="4426062" indent="0">
              <a:buNone/>
              <a:defRPr sz="1936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601594" y="5344160"/>
            <a:ext cx="4704013" cy="786045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C7F62-993A-4232-8570-CB5A3DEC7942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F608E-C378-4419-9361-F73511E64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992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C7F62-993A-4232-8570-CB5A3DEC7942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F608E-C378-4419-9361-F73511E64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5120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C7F62-993A-4232-8570-CB5A3DEC7942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F608E-C378-4419-9361-F73511E64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5517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2151" y="975360"/>
            <a:ext cx="3568710" cy="3413760"/>
          </a:xfrm>
        </p:spPr>
        <p:txBody>
          <a:bodyPr anchor="b"/>
          <a:lstStyle>
            <a:lvl1pPr>
              <a:defRPr sz="387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04013" y="2106510"/>
            <a:ext cx="5601593" cy="10397067"/>
          </a:xfrm>
        </p:spPr>
        <p:txBody>
          <a:bodyPr/>
          <a:lstStyle>
            <a:lvl1pPr>
              <a:defRPr sz="3872"/>
            </a:lvl1pPr>
            <a:lvl2pPr>
              <a:defRPr sz="3388"/>
            </a:lvl2pPr>
            <a:lvl3pPr>
              <a:defRPr sz="2904"/>
            </a:lvl3pPr>
            <a:lvl4pPr>
              <a:defRPr sz="2420"/>
            </a:lvl4pPr>
            <a:lvl5pPr>
              <a:defRPr sz="2420"/>
            </a:lvl5pPr>
            <a:lvl6pPr>
              <a:defRPr sz="2420"/>
            </a:lvl6pPr>
            <a:lvl7pPr>
              <a:defRPr sz="2420"/>
            </a:lvl7pPr>
            <a:lvl8pPr>
              <a:defRPr sz="2420"/>
            </a:lvl8pPr>
            <a:lvl9pPr>
              <a:defRPr sz="242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2151" y="4389120"/>
            <a:ext cx="3568710" cy="8131388"/>
          </a:xfrm>
        </p:spPr>
        <p:txBody>
          <a:bodyPr/>
          <a:lstStyle>
            <a:lvl1pPr marL="0" indent="0">
              <a:buNone/>
              <a:defRPr sz="1936"/>
            </a:lvl1pPr>
            <a:lvl2pPr marL="553258" indent="0">
              <a:buNone/>
              <a:defRPr sz="1694"/>
            </a:lvl2pPr>
            <a:lvl3pPr marL="1106515" indent="0">
              <a:buNone/>
              <a:defRPr sz="1452"/>
            </a:lvl3pPr>
            <a:lvl4pPr marL="1659773" indent="0">
              <a:buNone/>
              <a:defRPr sz="1210"/>
            </a:lvl4pPr>
            <a:lvl5pPr marL="2213031" indent="0">
              <a:buNone/>
              <a:defRPr sz="1210"/>
            </a:lvl5pPr>
            <a:lvl6pPr marL="2766289" indent="0">
              <a:buNone/>
              <a:defRPr sz="1210"/>
            </a:lvl6pPr>
            <a:lvl7pPr marL="3319546" indent="0">
              <a:buNone/>
              <a:defRPr sz="1210"/>
            </a:lvl7pPr>
            <a:lvl8pPr marL="3872804" indent="0">
              <a:buNone/>
              <a:defRPr sz="1210"/>
            </a:lvl8pPr>
            <a:lvl9pPr marL="4426062" indent="0">
              <a:buNone/>
              <a:defRPr sz="121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C7F62-993A-4232-8570-CB5A3DEC7942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F608E-C378-4419-9361-F73511E64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17799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62151" y="975360"/>
            <a:ext cx="3568710" cy="3413760"/>
          </a:xfrm>
        </p:spPr>
        <p:txBody>
          <a:bodyPr anchor="b"/>
          <a:lstStyle>
            <a:lvl1pPr>
              <a:defRPr sz="3872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704013" y="2106510"/>
            <a:ext cx="5601593" cy="10397067"/>
          </a:xfrm>
        </p:spPr>
        <p:txBody>
          <a:bodyPr anchor="t"/>
          <a:lstStyle>
            <a:lvl1pPr marL="0" indent="0">
              <a:buNone/>
              <a:defRPr sz="3872"/>
            </a:lvl1pPr>
            <a:lvl2pPr marL="553258" indent="0">
              <a:buNone/>
              <a:defRPr sz="3388"/>
            </a:lvl2pPr>
            <a:lvl3pPr marL="1106515" indent="0">
              <a:buNone/>
              <a:defRPr sz="2904"/>
            </a:lvl3pPr>
            <a:lvl4pPr marL="1659773" indent="0">
              <a:buNone/>
              <a:defRPr sz="2420"/>
            </a:lvl4pPr>
            <a:lvl5pPr marL="2213031" indent="0">
              <a:buNone/>
              <a:defRPr sz="2420"/>
            </a:lvl5pPr>
            <a:lvl6pPr marL="2766289" indent="0">
              <a:buNone/>
              <a:defRPr sz="2420"/>
            </a:lvl6pPr>
            <a:lvl7pPr marL="3319546" indent="0">
              <a:buNone/>
              <a:defRPr sz="2420"/>
            </a:lvl7pPr>
            <a:lvl8pPr marL="3872804" indent="0">
              <a:buNone/>
              <a:defRPr sz="2420"/>
            </a:lvl8pPr>
            <a:lvl9pPr marL="4426062" indent="0">
              <a:buNone/>
              <a:defRPr sz="242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62151" y="4389120"/>
            <a:ext cx="3568710" cy="8131388"/>
          </a:xfrm>
        </p:spPr>
        <p:txBody>
          <a:bodyPr/>
          <a:lstStyle>
            <a:lvl1pPr marL="0" indent="0">
              <a:buNone/>
              <a:defRPr sz="1936"/>
            </a:lvl1pPr>
            <a:lvl2pPr marL="553258" indent="0">
              <a:buNone/>
              <a:defRPr sz="1694"/>
            </a:lvl2pPr>
            <a:lvl3pPr marL="1106515" indent="0">
              <a:buNone/>
              <a:defRPr sz="1452"/>
            </a:lvl3pPr>
            <a:lvl4pPr marL="1659773" indent="0">
              <a:buNone/>
              <a:defRPr sz="1210"/>
            </a:lvl4pPr>
            <a:lvl5pPr marL="2213031" indent="0">
              <a:buNone/>
              <a:defRPr sz="1210"/>
            </a:lvl5pPr>
            <a:lvl6pPr marL="2766289" indent="0">
              <a:buNone/>
              <a:defRPr sz="1210"/>
            </a:lvl6pPr>
            <a:lvl7pPr marL="3319546" indent="0">
              <a:buNone/>
              <a:defRPr sz="1210"/>
            </a:lvl7pPr>
            <a:lvl8pPr marL="3872804" indent="0">
              <a:buNone/>
              <a:defRPr sz="1210"/>
            </a:lvl8pPr>
            <a:lvl9pPr marL="4426062" indent="0">
              <a:buNone/>
              <a:defRPr sz="121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C7F62-993A-4232-8570-CB5A3DEC7942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2F608E-C378-4419-9361-F73511E64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27187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60710" y="778936"/>
            <a:ext cx="9543455" cy="282786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60710" y="3894667"/>
            <a:ext cx="9543455" cy="928285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60710" y="13560217"/>
            <a:ext cx="2489597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FC7F62-993A-4232-8570-CB5A3DEC7942}" type="datetimeFigureOut">
              <a:rPr lang="en-US" smtClean="0"/>
              <a:t>8/26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665240" y="13560217"/>
            <a:ext cx="3734395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814568" y="13560217"/>
            <a:ext cx="2489597" cy="7789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5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2F608E-C378-4419-9361-F73511E6457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3179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106515" rtl="0" eaLnBrk="1" latinLnBrk="0" hangingPunct="1">
        <a:lnSpc>
          <a:spcPct val="90000"/>
        </a:lnSpc>
        <a:spcBef>
          <a:spcPct val="0"/>
        </a:spcBef>
        <a:buNone/>
        <a:defRPr sz="53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6629" indent="-276629" algn="l" defTabSz="1106515" rtl="0" eaLnBrk="1" latinLnBrk="0" hangingPunct="1">
        <a:lnSpc>
          <a:spcPct val="90000"/>
        </a:lnSpc>
        <a:spcBef>
          <a:spcPts val="1210"/>
        </a:spcBef>
        <a:buFont typeface="Arial" panose="020B0604020202020204" pitchFamily="34" charset="0"/>
        <a:buChar char="•"/>
        <a:defRPr sz="3388" kern="1200">
          <a:solidFill>
            <a:schemeClr val="tx1"/>
          </a:solidFill>
          <a:latin typeface="+mn-lt"/>
          <a:ea typeface="+mn-ea"/>
          <a:cs typeface="+mn-cs"/>
        </a:defRPr>
      </a:lvl1pPr>
      <a:lvl2pPr marL="829887" indent="-276629" algn="l" defTabSz="1106515" rtl="0" eaLnBrk="1" latinLnBrk="0" hangingPunct="1">
        <a:lnSpc>
          <a:spcPct val="90000"/>
        </a:lnSpc>
        <a:spcBef>
          <a:spcPts val="605"/>
        </a:spcBef>
        <a:buFont typeface="Arial" panose="020B0604020202020204" pitchFamily="34" charset="0"/>
        <a:buChar char="•"/>
        <a:defRPr sz="2904" kern="1200">
          <a:solidFill>
            <a:schemeClr val="tx1"/>
          </a:solidFill>
          <a:latin typeface="+mn-lt"/>
          <a:ea typeface="+mn-ea"/>
          <a:cs typeface="+mn-cs"/>
        </a:defRPr>
      </a:lvl2pPr>
      <a:lvl3pPr marL="1383144" indent="-276629" algn="l" defTabSz="1106515" rtl="0" eaLnBrk="1" latinLnBrk="0" hangingPunct="1">
        <a:lnSpc>
          <a:spcPct val="90000"/>
        </a:lnSpc>
        <a:spcBef>
          <a:spcPts val="605"/>
        </a:spcBef>
        <a:buFont typeface="Arial" panose="020B0604020202020204" pitchFamily="34" charset="0"/>
        <a:buChar char="•"/>
        <a:defRPr sz="2420" kern="1200">
          <a:solidFill>
            <a:schemeClr val="tx1"/>
          </a:solidFill>
          <a:latin typeface="+mn-lt"/>
          <a:ea typeface="+mn-ea"/>
          <a:cs typeface="+mn-cs"/>
        </a:defRPr>
      </a:lvl3pPr>
      <a:lvl4pPr marL="1936402" indent="-276629" algn="l" defTabSz="1106515" rtl="0" eaLnBrk="1" latinLnBrk="0" hangingPunct="1">
        <a:lnSpc>
          <a:spcPct val="90000"/>
        </a:lnSpc>
        <a:spcBef>
          <a:spcPts val="605"/>
        </a:spcBef>
        <a:buFont typeface="Arial" panose="020B0604020202020204" pitchFamily="34" charset="0"/>
        <a:buChar char="•"/>
        <a:defRPr sz="2178" kern="1200">
          <a:solidFill>
            <a:schemeClr val="tx1"/>
          </a:solidFill>
          <a:latin typeface="+mn-lt"/>
          <a:ea typeface="+mn-ea"/>
          <a:cs typeface="+mn-cs"/>
        </a:defRPr>
      </a:lvl4pPr>
      <a:lvl5pPr marL="2489660" indent="-276629" algn="l" defTabSz="1106515" rtl="0" eaLnBrk="1" latinLnBrk="0" hangingPunct="1">
        <a:lnSpc>
          <a:spcPct val="90000"/>
        </a:lnSpc>
        <a:spcBef>
          <a:spcPts val="605"/>
        </a:spcBef>
        <a:buFont typeface="Arial" panose="020B0604020202020204" pitchFamily="34" charset="0"/>
        <a:buChar char="•"/>
        <a:defRPr sz="2178" kern="1200">
          <a:solidFill>
            <a:schemeClr val="tx1"/>
          </a:solidFill>
          <a:latin typeface="+mn-lt"/>
          <a:ea typeface="+mn-ea"/>
          <a:cs typeface="+mn-cs"/>
        </a:defRPr>
      </a:lvl5pPr>
      <a:lvl6pPr marL="3042917" indent="-276629" algn="l" defTabSz="1106515" rtl="0" eaLnBrk="1" latinLnBrk="0" hangingPunct="1">
        <a:lnSpc>
          <a:spcPct val="90000"/>
        </a:lnSpc>
        <a:spcBef>
          <a:spcPts val="605"/>
        </a:spcBef>
        <a:buFont typeface="Arial" panose="020B0604020202020204" pitchFamily="34" charset="0"/>
        <a:buChar char="•"/>
        <a:defRPr sz="2178" kern="1200">
          <a:solidFill>
            <a:schemeClr val="tx1"/>
          </a:solidFill>
          <a:latin typeface="+mn-lt"/>
          <a:ea typeface="+mn-ea"/>
          <a:cs typeface="+mn-cs"/>
        </a:defRPr>
      </a:lvl6pPr>
      <a:lvl7pPr marL="3596175" indent="-276629" algn="l" defTabSz="1106515" rtl="0" eaLnBrk="1" latinLnBrk="0" hangingPunct="1">
        <a:lnSpc>
          <a:spcPct val="90000"/>
        </a:lnSpc>
        <a:spcBef>
          <a:spcPts val="605"/>
        </a:spcBef>
        <a:buFont typeface="Arial" panose="020B0604020202020204" pitchFamily="34" charset="0"/>
        <a:buChar char="•"/>
        <a:defRPr sz="2178" kern="1200">
          <a:solidFill>
            <a:schemeClr val="tx1"/>
          </a:solidFill>
          <a:latin typeface="+mn-lt"/>
          <a:ea typeface="+mn-ea"/>
          <a:cs typeface="+mn-cs"/>
        </a:defRPr>
      </a:lvl7pPr>
      <a:lvl8pPr marL="4149433" indent="-276629" algn="l" defTabSz="1106515" rtl="0" eaLnBrk="1" latinLnBrk="0" hangingPunct="1">
        <a:lnSpc>
          <a:spcPct val="90000"/>
        </a:lnSpc>
        <a:spcBef>
          <a:spcPts val="605"/>
        </a:spcBef>
        <a:buFont typeface="Arial" panose="020B0604020202020204" pitchFamily="34" charset="0"/>
        <a:buChar char="•"/>
        <a:defRPr sz="2178" kern="1200">
          <a:solidFill>
            <a:schemeClr val="tx1"/>
          </a:solidFill>
          <a:latin typeface="+mn-lt"/>
          <a:ea typeface="+mn-ea"/>
          <a:cs typeface="+mn-cs"/>
        </a:defRPr>
      </a:lvl8pPr>
      <a:lvl9pPr marL="4702691" indent="-276629" algn="l" defTabSz="1106515" rtl="0" eaLnBrk="1" latinLnBrk="0" hangingPunct="1">
        <a:lnSpc>
          <a:spcPct val="90000"/>
        </a:lnSpc>
        <a:spcBef>
          <a:spcPts val="605"/>
        </a:spcBef>
        <a:buFont typeface="Arial" panose="020B0604020202020204" pitchFamily="34" charset="0"/>
        <a:buChar char="•"/>
        <a:defRPr sz="217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06515" rtl="0" eaLnBrk="1" latinLnBrk="0" hangingPunct="1">
        <a:defRPr sz="2178" kern="1200">
          <a:solidFill>
            <a:schemeClr val="tx1"/>
          </a:solidFill>
          <a:latin typeface="+mn-lt"/>
          <a:ea typeface="+mn-ea"/>
          <a:cs typeface="+mn-cs"/>
        </a:defRPr>
      </a:lvl1pPr>
      <a:lvl2pPr marL="553258" algn="l" defTabSz="1106515" rtl="0" eaLnBrk="1" latinLnBrk="0" hangingPunct="1">
        <a:defRPr sz="2178" kern="1200">
          <a:solidFill>
            <a:schemeClr val="tx1"/>
          </a:solidFill>
          <a:latin typeface="+mn-lt"/>
          <a:ea typeface="+mn-ea"/>
          <a:cs typeface="+mn-cs"/>
        </a:defRPr>
      </a:lvl2pPr>
      <a:lvl3pPr marL="1106515" algn="l" defTabSz="1106515" rtl="0" eaLnBrk="1" latinLnBrk="0" hangingPunct="1">
        <a:defRPr sz="2178" kern="1200">
          <a:solidFill>
            <a:schemeClr val="tx1"/>
          </a:solidFill>
          <a:latin typeface="+mn-lt"/>
          <a:ea typeface="+mn-ea"/>
          <a:cs typeface="+mn-cs"/>
        </a:defRPr>
      </a:lvl3pPr>
      <a:lvl4pPr marL="1659773" algn="l" defTabSz="1106515" rtl="0" eaLnBrk="1" latinLnBrk="0" hangingPunct="1">
        <a:defRPr sz="2178" kern="1200">
          <a:solidFill>
            <a:schemeClr val="tx1"/>
          </a:solidFill>
          <a:latin typeface="+mn-lt"/>
          <a:ea typeface="+mn-ea"/>
          <a:cs typeface="+mn-cs"/>
        </a:defRPr>
      </a:lvl4pPr>
      <a:lvl5pPr marL="2213031" algn="l" defTabSz="1106515" rtl="0" eaLnBrk="1" latinLnBrk="0" hangingPunct="1">
        <a:defRPr sz="2178" kern="1200">
          <a:solidFill>
            <a:schemeClr val="tx1"/>
          </a:solidFill>
          <a:latin typeface="+mn-lt"/>
          <a:ea typeface="+mn-ea"/>
          <a:cs typeface="+mn-cs"/>
        </a:defRPr>
      </a:lvl5pPr>
      <a:lvl6pPr marL="2766289" algn="l" defTabSz="1106515" rtl="0" eaLnBrk="1" latinLnBrk="0" hangingPunct="1">
        <a:defRPr sz="2178" kern="1200">
          <a:solidFill>
            <a:schemeClr val="tx1"/>
          </a:solidFill>
          <a:latin typeface="+mn-lt"/>
          <a:ea typeface="+mn-ea"/>
          <a:cs typeface="+mn-cs"/>
        </a:defRPr>
      </a:lvl6pPr>
      <a:lvl7pPr marL="3319546" algn="l" defTabSz="1106515" rtl="0" eaLnBrk="1" latinLnBrk="0" hangingPunct="1">
        <a:defRPr sz="2178" kern="1200">
          <a:solidFill>
            <a:schemeClr val="tx1"/>
          </a:solidFill>
          <a:latin typeface="+mn-lt"/>
          <a:ea typeface="+mn-ea"/>
          <a:cs typeface="+mn-cs"/>
        </a:defRPr>
      </a:lvl7pPr>
      <a:lvl8pPr marL="3872804" algn="l" defTabSz="1106515" rtl="0" eaLnBrk="1" latinLnBrk="0" hangingPunct="1">
        <a:defRPr sz="2178" kern="1200">
          <a:solidFill>
            <a:schemeClr val="tx1"/>
          </a:solidFill>
          <a:latin typeface="+mn-lt"/>
          <a:ea typeface="+mn-ea"/>
          <a:cs typeface="+mn-cs"/>
        </a:defRPr>
      </a:lvl8pPr>
      <a:lvl9pPr marL="4426062" algn="l" defTabSz="1106515" rtl="0" eaLnBrk="1" latinLnBrk="0" hangingPunct="1">
        <a:defRPr sz="217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7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4" name="Objec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53375182"/>
              </p:ext>
            </p:extLst>
          </p:nvPr>
        </p:nvGraphicFramePr>
        <p:xfrm>
          <a:off x="1243659" y="866481"/>
          <a:ext cx="2955925" cy="367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65" name="Prism 8" r:id="rId3" imgW="2955994" imgH="3679322" progId="Prism8.Document">
                  <p:embed/>
                </p:oleObj>
              </mc:Choice>
              <mc:Fallback>
                <p:oleObj name="Prism 8" r:id="rId3" imgW="2955994" imgH="3679322" progId="Prism8.Document">
                  <p:embed/>
                  <p:pic>
                    <p:nvPicPr>
                      <p:cNvPr id="16" name="Object 15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243659" y="866481"/>
                        <a:ext cx="2955925" cy="3679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4444155"/>
              </p:ext>
            </p:extLst>
          </p:nvPr>
        </p:nvGraphicFramePr>
        <p:xfrm>
          <a:off x="4199584" y="866481"/>
          <a:ext cx="2955925" cy="367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66" name="Prism 8" r:id="rId5" imgW="2955994" imgH="3679322" progId="Prism8.Document">
                  <p:embed/>
                </p:oleObj>
              </mc:Choice>
              <mc:Fallback>
                <p:oleObj name="Prism 8" r:id="rId5" imgW="2955994" imgH="3679322" progId="Prism8.Document">
                  <p:embed/>
                  <p:pic>
                    <p:nvPicPr>
                      <p:cNvPr id="17" name="Object 16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199584" y="866481"/>
                        <a:ext cx="2955925" cy="3679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ct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24620825"/>
              </p:ext>
            </p:extLst>
          </p:nvPr>
        </p:nvGraphicFramePr>
        <p:xfrm>
          <a:off x="7155509" y="866481"/>
          <a:ext cx="2955925" cy="367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67" name="Prism 8" r:id="rId7" imgW="2955994" imgH="3679322" progId="Prism8.Document">
                  <p:embed/>
                </p:oleObj>
              </mc:Choice>
              <mc:Fallback>
                <p:oleObj name="Prism 8" r:id="rId7" imgW="2955994" imgH="3679322" progId="Prism8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155509" y="866481"/>
                        <a:ext cx="2955925" cy="3679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c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5203819"/>
              </p:ext>
            </p:extLst>
          </p:nvPr>
        </p:nvGraphicFramePr>
        <p:xfrm>
          <a:off x="1243659" y="4502942"/>
          <a:ext cx="2955925" cy="367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68" name="Prism 8" r:id="rId9" imgW="2955994" imgH="3679322" progId="Prism8.Document">
                  <p:embed/>
                </p:oleObj>
              </mc:Choice>
              <mc:Fallback>
                <p:oleObj name="Prism 8" r:id="rId9" imgW="2955994" imgH="3679322" progId="Prism8.Document">
                  <p:embed/>
                  <p:pic>
                    <p:nvPicPr>
                      <p:cNvPr id="19" name="Object 18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243659" y="4502942"/>
                        <a:ext cx="2955925" cy="3679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c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37827423"/>
              </p:ext>
            </p:extLst>
          </p:nvPr>
        </p:nvGraphicFramePr>
        <p:xfrm>
          <a:off x="4199584" y="4502942"/>
          <a:ext cx="2955925" cy="367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69" name="Prism 8" r:id="rId11" imgW="2955994" imgH="3679322" progId="Prism8.Document">
                  <p:embed/>
                </p:oleObj>
              </mc:Choice>
              <mc:Fallback>
                <p:oleObj name="Prism 8" r:id="rId11" imgW="2955994" imgH="3679322" progId="Prism8.Document">
                  <p:embed/>
                  <p:pic>
                    <p:nvPicPr>
                      <p:cNvPr id="20" name="Object 19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199584" y="4502942"/>
                        <a:ext cx="2955925" cy="3679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c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0146008"/>
              </p:ext>
            </p:extLst>
          </p:nvPr>
        </p:nvGraphicFramePr>
        <p:xfrm>
          <a:off x="7155509" y="4502942"/>
          <a:ext cx="2873375" cy="367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0" name="Prism 8" r:id="rId13" imgW="2873883" imgH="3679322" progId="Prism8.Document">
                  <p:embed/>
                </p:oleObj>
              </mc:Choice>
              <mc:Fallback>
                <p:oleObj name="Prism 8" r:id="rId13" imgW="2873883" imgH="3679322" progId="Prism8.Document">
                  <p:embed/>
                  <p:pic>
                    <p:nvPicPr>
                      <p:cNvPr id="21" name="Object 20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7155509" y="4502942"/>
                        <a:ext cx="2873375" cy="3679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53675042"/>
              </p:ext>
            </p:extLst>
          </p:nvPr>
        </p:nvGraphicFramePr>
        <p:xfrm>
          <a:off x="1243659" y="8139402"/>
          <a:ext cx="3930650" cy="36718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71" name="Prism 8" r:id="rId15" imgW="3930521" imgH="3671761" progId="Prism8.Document">
                  <p:embed/>
                </p:oleObj>
              </mc:Choice>
              <mc:Fallback>
                <p:oleObj name="Prism 8" r:id="rId15" imgW="3930521" imgH="3671761" progId="Prism8.Document">
                  <p:embed/>
                  <p:pic>
                    <p:nvPicPr>
                      <p:cNvPr id="22" name="Object 21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243659" y="8139402"/>
                        <a:ext cx="3930650" cy="36718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Box 32"/>
          <p:cNvSpPr txBox="1"/>
          <p:nvPr/>
        </p:nvSpPr>
        <p:spPr>
          <a:xfrm>
            <a:off x="88406" y="174780"/>
            <a:ext cx="252184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sz="1600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18663" y="12094772"/>
            <a:ext cx="10317765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ry Figure </a:t>
            </a:r>
            <a:r>
              <a:rPr lang="en-US" sz="1600" b="1" dirty="0" smtClean="0"/>
              <a:t>5.  </a:t>
            </a:r>
            <a:r>
              <a:rPr lang="en-US" sz="1600" b="1" dirty="0"/>
              <a:t>Viability assays for various cell lines exposed to iP300w.</a:t>
            </a:r>
            <a:endParaRPr lang="en-US" sz="1600" dirty="0"/>
          </a:p>
          <a:p>
            <a:r>
              <a:rPr lang="en-US" sz="1600" dirty="0"/>
              <a:t>A.  ATP assay for cell viability on </a:t>
            </a:r>
            <a:r>
              <a:rPr lang="en-US" sz="1600" dirty="0" smtClean="0"/>
              <a:t>Panc1, MiaPaca2, CFPac1 </a:t>
            </a:r>
            <a:r>
              <a:rPr lang="en-US" sz="1600" dirty="0"/>
              <a:t>pancreatic cancer cells treated with serial of iP300w dilutions for 48 hours. </a:t>
            </a:r>
          </a:p>
          <a:p>
            <a:r>
              <a:rPr lang="en-US" sz="1600" dirty="0"/>
              <a:t>B.  ATP assay for cell viability on </a:t>
            </a:r>
            <a:r>
              <a:rPr lang="en-US" sz="1600" dirty="0" smtClean="0"/>
              <a:t>HTC116, MKN28, KATO3 </a:t>
            </a:r>
            <a:r>
              <a:rPr lang="en-US" sz="1600" dirty="0"/>
              <a:t>colorectal cancer cells treated with serial of iP300w dilutions for 48 hours.</a:t>
            </a:r>
          </a:p>
          <a:p>
            <a:r>
              <a:rPr lang="en-US" sz="1600" dirty="0"/>
              <a:t>C.  ATP assay on LCHN-Myoblast treated for 48 and </a:t>
            </a:r>
            <a:r>
              <a:rPr lang="en-US" sz="1600" dirty="0" smtClean="0"/>
              <a:t>72 </a:t>
            </a:r>
            <a:r>
              <a:rPr lang="en-US" sz="1600" dirty="0"/>
              <a:t>hours with iP300w. </a:t>
            </a:r>
            <a:r>
              <a:rPr lang="en-GB" sz="1600" dirty="0"/>
              <a:t>Data are presented as mean ± SEM;  ***p&lt;0.001, ****p&lt;0.0001 by one-way ANOVA,  n=4.</a:t>
            </a:r>
            <a:endParaRPr lang="en-US" sz="1600" dirty="0"/>
          </a:p>
        </p:txBody>
      </p:sp>
      <p:sp>
        <p:nvSpPr>
          <p:cNvPr id="35" name="TextBox 34"/>
          <p:cNvSpPr txBox="1"/>
          <p:nvPr/>
        </p:nvSpPr>
        <p:spPr>
          <a:xfrm>
            <a:off x="1282206" y="7125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282206" y="43574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282206" y="800233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58331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</TotalTime>
  <Words>106</Words>
  <Application>Microsoft Office PowerPoint</Application>
  <PresentationFormat>Custom</PresentationFormat>
  <Paragraphs>8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8</vt:lpstr>
      <vt:lpstr>PowerPoint Presentation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ko Bosnakovski</dc:creator>
  <cp:lastModifiedBy>Darko Bosnakovski</cp:lastModifiedBy>
  <cp:revision>12</cp:revision>
  <dcterms:created xsi:type="dcterms:W3CDTF">2021-01-13T18:44:53Z</dcterms:created>
  <dcterms:modified xsi:type="dcterms:W3CDTF">2021-08-26T16:07:45Z</dcterms:modified>
</cp:coreProperties>
</file>